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433D4-35D6-495A-9C41-6E6FA72445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DC2CE-69C4-4112-B8DD-BA495F29D4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B740A-5E4F-4CB4-B46B-AFCDD9C21E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D3CD39-0C13-4FA2-B788-66278E91CB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25B51-6648-4334-96C4-064DCF2314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92D5A-2D18-4A76-862E-89EBA0513C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3ADE5-C865-4A65-98F0-6B39F88EE0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43864-1700-44AF-B6BA-074066C03A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CFA45-DF54-45AE-A7BB-B57237C64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E478F-1562-43D0-A1B0-C6962E0D76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D6636A-65F8-45B4-BD73-6A9F5F85B1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EC20A-AFD1-44AE-B18F-2045D183C8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4EB7BC-56E6-4D33-99D3-7ACF05A38183}" type="slidenum">
              <a:rPr b="0" lang="fr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6" descr=""/>
          <p:cNvPicPr/>
          <p:nvPr/>
        </p:nvPicPr>
        <p:blipFill>
          <a:blip r:embed="rId1"/>
          <a:stretch/>
        </p:blipFill>
        <p:spPr>
          <a:xfrm>
            <a:off x="3490920" y="2936880"/>
            <a:ext cx="3106800" cy="2239920"/>
          </a:xfrm>
          <a:prstGeom prst="rect">
            <a:avLst/>
          </a:prstGeom>
          <a:ln w="0">
            <a:noFill/>
          </a:ln>
        </p:spPr>
      </p:pic>
      <p:pic>
        <p:nvPicPr>
          <p:cNvPr id="42" name="Image 8" descr=""/>
          <p:cNvPicPr/>
          <p:nvPr/>
        </p:nvPicPr>
        <p:blipFill>
          <a:blip r:embed="rId2"/>
          <a:srcRect l="0" t="0" r="12394" b="0"/>
          <a:stretch/>
        </p:blipFill>
        <p:spPr>
          <a:xfrm>
            <a:off x="330120" y="2624040"/>
            <a:ext cx="3111480" cy="2560680"/>
          </a:xfrm>
          <a:prstGeom prst="rect">
            <a:avLst/>
          </a:prstGeom>
          <a:ln w="0">
            <a:noFill/>
          </a:ln>
        </p:spPr>
      </p:pic>
      <p:pic>
        <p:nvPicPr>
          <p:cNvPr id="43" name="Image 9" descr=""/>
          <p:cNvPicPr/>
          <p:nvPr/>
        </p:nvPicPr>
        <p:blipFill>
          <a:blip r:embed="rId3"/>
          <a:srcRect l="0" t="0" r="12667" b="0"/>
          <a:stretch/>
        </p:blipFill>
        <p:spPr>
          <a:xfrm>
            <a:off x="330120" y="5530680"/>
            <a:ext cx="3100320" cy="2559240"/>
          </a:xfrm>
          <a:prstGeom prst="rect">
            <a:avLst/>
          </a:prstGeom>
          <a:ln w="0">
            <a:noFill/>
          </a:ln>
        </p:spPr>
      </p:pic>
      <p:pic>
        <p:nvPicPr>
          <p:cNvPr id="44" name="Image 10" descr=""/>
          <p:cNvPicPr/>
          <p:nvPr/>
        </p:nvPicPr>
        <p:blipFill>
          <a:blip r:embed="rId4"/>
          <a:srcRect l="0" t="0" r="12830" b="0"/>
          <a:stretch/>
        </p:blipFill>
        <p:spPr>
          <a:xfrm>
            <a:off x="3467160" y="5527800"/>
            <a:ext cx="3100320" cy="2560680"/>
          </a:xfrm>
          <a:prstGeom prst="rect">
            <a:avLst/>
          </a:prstGeom>
          <a:ln w="0">
            <a:noFill/>
          </a:ln>
        </p:spPr>
      </p:pic>
      <p:sp>
        <p:nvSpPr>
          <p:cNvPr id="45" name="ZoneTexte 3"/>
          <p:cNvSpPr/>
          <p:nvPr/>
        </p:nvSpPr>
        <p:spPr>
          <a:xfrm>
            <a:off x="339120" y="826920"/>
            <a:ext cx="219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Arial"/>
              </a:rPr>
              <a:t>A: Canonical Pathways (C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12"/>
          <p:cNvSpPr/>
          <p:nvPr/>
        </p:nvSpPr>
        <p:spPr>
          <a:xfrm>
            <a:off x="337320" y="2363760"/>
            <a:ext cx="140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Arial"/>
              </a:rPr>
              <a:t>C: Cell migr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13"/>
          <p:cNvSpPr/>
          <p:nvPr/>
        </p:nvSpPr>
        <p:spPr>
          <a:xfrm>
            <a:off x="2654640" y="826920"/>
            <a:ext cx="22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Arial"/>
              </a:rPr>
              <a:t>B: Biological Processes (C5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15"/>
          <p:cNvSpPr/>
          <p:nvPr/>
        </p:nvSpPr>
        <p:spPr>
          <a:xfrm>
            <a:off x="3472560" y="2363760"/>
            <a:ext cx="124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Arial"/>
              </a:rPr>
              <a:t>D: Chemotaxi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16"/>
          <p:cNvSpPr/>
          <p:nvPr/>
        </p:nvSpPr>
        <p:spPr>
          <a:xfrm>
            <a:off x="339120" y="5257800"/>
            <a:ext cx="171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Arial"/>
              </a:rPr>
              <a:t>E: Cell differenti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17"/>
          <p:cNvSpPr/>
          <p:nvPr/>
        </p:nvSpPr>
        <p:spPr>
          <a:xfrm>
            <a:off x="3471840" y="5257800"/>
            <a:ext cx="189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Arial"/>
              </a:rPr>
              <a:t>F: Transcription facto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98"/>
          <p:cNvSpPr/>
          <p:nvPr/>
        </p:nvSpPr>
        <p:spPr>
          <a:xfrm>
            <a:off x="4815720" y="8815320"/>
            <a:ext cx="196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acleche et al., Suppl. Figur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Image 4" descr=""/>
          <p:cNvPicPr/>
          <p:nvPr/>
        </p:nvPicPr>
        <p:blipFill>
          <a:blip r:embed="rId5"/>
          <a:srcRect l="16115" t="12468" r="14576" b="0"/>
          <a:stretch/>
        </p:blipFill>
        <p:spPr>
          <a:xfrm>
            <a:off x="1009800" y="1104840"/>
            <a:ext cx="1054080" cy="1351080"/>
          </a:xfrm>
          <a:prstGeom prst="rect">
            <a:avLst/>
          </a:prstGeom>
          <a:ln w="0">
            <a:noFill/>
          </a:ln>
        </p:spPr>
      </p:pic>
      <p:pic>
        <p:nvPicPr>
          <p:cNvPr id="53" name="Image 19" descr=""/>
          <p:cNvPicPr/>
          <p:nvPr/>
        </p:nvPicPr>
        <p:blipFill>
          <a:blip r:embed="rId6"/>
          <a:srcRect l="16361" t="13307" r="16012" b="45"/>
          <a:stretch/>
        </p:blipFill>
        <p:spPr>
          <a:xfrm>
            <a:off x="3213000" y="1108080"/>
            <a:ext cx="1082880" cy="138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30T21:09:45Z</dcterms:created>
  <dc:creator>Wacleche Vanessa Sue</dc:creator>
  <dc:description/>
  <dc:language>en-US</dc:language>
  <cp:lastModifiedBy>sspira</cp:lastModifiedBy>
  <dcterms:modified xsi:type="dcterms:W3CDTF">2016-08-10T23:51:42Z</dcterms:modified>
  <cp:revision>10</cp:revision>
  <dc:subject/>
  <dc:title>Présentation PowerPoint</dc:title>
</cp:coreProperties>
</file>